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398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36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996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51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926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507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723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9532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844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373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514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F6F247-4B66-44C9-AB2B-1A563244A002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6794B4-A4CB-4A5E-97DE-33CB1E9D2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520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Relationship Id="rId6" Type="http://schemas.microsoft.com/office/2007/relationships/hdphoto" Target="../media/hdphoto5.wdp"/><Relationship Id="rId5" Type="http://schemas.openxmlformats.org/officeDocument/2006/relationships/image" Target="../media/image7.png"/><Relationship Id="rId4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600" y="237744"/>
            <a:ext cx="1082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G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800" t="55254" r="25578" b="25726"/>
          <a:stretch/>
        </p:blipFill>
        <p:spPr>
          <a:xfrm>
            <a:off x="1581912" y="2825496"/>
            <a:ext cx="4510792" cy="144773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530" t="28920" r="29993" b="50405"/>
          <a:stretch/>
        </p:blipFill>
        <p:spPr>
          <a:xfrm>
            <a:off x="1581912" y="4346386"/>
            <a:ext cx="4510792" cy="154972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068" t="44823" r="30731" b="36266"/>
          <a:stretch/>
        </p:blipFill>
        <p:spPr>
          <a:xfrm>
            <a:off x="1581912" y="1338069"/>
            <a:ext cx="4510792" cy="141427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581912" y="1356357"/>
            <a:ext cx="530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>
                <a:solidFill>
                  <a:schemeClr val="bg1"/>
                </a:solidFill>
              </a:rPr>
              <a:t>kDa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25428" y="2008321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33242" y="2223269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5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25428" y="2437312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3</a:t>
            </a:r>
            <a:r>
              <a:rPr lang="de-DE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733242" y="1888507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3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581912" y="2825496"/>
            <a:ext cx="530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>
                <a:solidFill>
                  <a:schemeClr val="bg1"/>
                </a:solidFill>
              </a:rPr>
              <a:t>kDa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25428" y="3477460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733242" y="3692408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5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25428" y="3906451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3</a:t>
            </a:r>
            <a:r>
              <a:rPr lang="de-DE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733242" y="3357646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3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17482" y="4328098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17482" y="4761572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1</a:t>
            </a:r>
            <a:r>
              <a:rPr lang="de-DE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25428" y="5076593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</a:t>
            </a:r>
            <a:r>
              <a:rPr lang="de-DE" sz="1050" dirty="0">
                <a:solidFill>
                  <a:schemeClr val="bg1"/>
                </a:solidFill>
              </a:rPr>
              <a:t>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86505" y="4531143"/>
            <a:ext cx="7902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Gpx4</a:t>
            </a:r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591626" y="3752562"/>
            <a:ext cx="923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ß-actin</a:t>
            </a:r>
            <a:endParaRPr 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586505" y="1926598"/>
            <a:ext cx="7393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Lrp8</a:t>
            </a:r>
            <a:endParaRPr lang="en-US" sz="1400" dirty="0"/>
          </a:p>
        </p:txBody>
      </p:sp>
      <p:sp>
        <p:nvSpPr>
          <p:cNvPr id="24" name="Rectangle 23"/>
          <p:cNvSpPr/>
          <p:nvPr/>
        </p:nvSpPr>
        <p:spPr>
          <a:xfrm>
            <a:off x="4244308" y="1926598"/>
            <a:ext cx="1772444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4244308" y="3726359"/>
            <a:ext cx="1772444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4244308" y="4645096"/>
            <a:ext cx="1772444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74" t="40501" r="24752" b="18174"/>
          <a:stretch/>
        </p:blipFill>
        <p:spPr>
          <a:xfrm>
            <a:off x="6821423" y="2043129"/>
            <a:ext cx="5047502" cy="3236437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6588639" y="6389040"/>
            <a:ext cx="5465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olorimetric and chemiluminecent signals were merged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4763280" y="527835"/>
            <a:ext cx="7027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rgbClr val="FF0000"/>
                </a:solidFill>
              </a:rPr>
              <a:t>Red boxes always indicate the cropped areas ther were used in the figure</a:t>
            </a:r>
          </a:p>
        </p:txBody>
      </p:sp>
    </p:spTree>
    <p:extLst>
      <p:ext uri="{BB962C8B-B14F-4D97-AF65-F5344CB8AC3E}">
        <p14:creationId xmlns:p14="http://schemas.microsoft.com/office/powerpoint/2010/main" val="29573284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84" t="67860" r="25927" b="28468"/>
          <a:stretch/>
        </p:blipFill>
        <p:spPr>
          <a:xfrm>
            <a:off x="4965192" y="4266398"/>
            <a:ext cx="3209544" cy="50677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594" t="33384" r="31614" b="63903"/>
          <a:stretch/>
        </p:blipFill>
        <p:spPr>
          <a:xfrm>
            <a:off x="4965192" y="3797655"/>
            <a:ext cx="3209544" cy="39011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784" t="53993" r="33009" b="43375"/>
          <a:stretch/>
        </p:blipFill>
        <p:spPr>
          <a:xfrm>
            <a:off x="4965192" y="3327137"/>
            <a:ext cx="3209544" cy="39188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4358332" y="3349690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Lrp8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295623" y="3818433"/>
            <a:ext cx="664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Gpx4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122690" y="4365809"/>
            <a:ext cx="8370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ß-acti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982845" y="2639044"/>
            <a:ext cx="8669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smtClean="0"/>
              <a:t>Control</a:t>
            </a:r>
          </a:p>
          <a:p>
            <a:r>
              <a:rPr lang="de-DE" i="1" dirty="0" err="1" smtClean="0"/>
              <a:t>sgRNA</a:t>
            </a:r>
            <a:endParaRPr lang="en-US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6026039" y="2818624"/>
            <a:ext cx="4603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s</a:t>
            </a:r>
            <a:r>
              <a:rPr lang="de-DE" sz="2400" dirty="0" smtClean="0"/>
              <a:t>1</a:t>
            </a:r>
            <a:endParaRPr lang="en-US" sz="2400" dirty="0"/>
          </a:p>
        </p:txBody>
      </p:sp>
      <p:sp>
        <p:nvSpPr>
          <p:cNvPr id="14" name="TextBox 13"/>
          <p:cNvSpPr txBox="1"/>
          <p:nvPr/>
        </p:nvSpPr>
        <p:spPr>
          <a:xfrm>
            <a:off x="6550269" y="2318664"/>
            <a:ext cx="1510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i="1" dirty="0" smtClean="0"/>
              <a:t>mLrp8_sgRNA</a:t>
            </a:r>
            <a:endParaRPr lang="en-US" dirty="0"/>
          </a:p>
        </p:txBody>
      </p:sp>
      <p:sp>
        <p:nvSpPr>
          <p:cNvPr id="15" name="TextBox 11"/>
          <p:cNvSpPr txBox="1"/>
          <p:nvPr/>
        </p:nvSpPr>
        <p:spPr>
          <a:xfrm>
            <a:off x="6839001" y="2831782"/>
            <a:ext cx="4603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 smtClean="0"/>
              <a:t>s2</a:t>
            </a:r>
            <a:endParaRPr lang="en-US" sz="2400" dirty="0"/>
          </a:p>
        </p:txBody>
      </p:sp>
      <p:sp>
        <p:nvSpPr>
          <p:cNvPr id="16" name="TextBox 11"/>
          <p:cNvSpPr txBox="1"/>
          <p:nvPr/>
        </p:nvSpPr>
        <p:spPr>
          <a:xfrm>
            <a:off x="7651963" y="2833934"/>
            <a:ext cx="4603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s4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0642416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Widescreen</PresentationFormat>
  <Paragraphs>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Julius-Maximilians-Universität Würz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iyi Chen</dc:creator>
  <cp:lastModifiedBy>Zhiyi Chen</cp:lastModifiedBy>
  <cp:revision>6</cp:revision>
  <dcterms:created xsi:type="dcterms:W3CDTF">2021-12-02T13:40:57Z</dcterms:created>
  <dcterms:modified xsi:type="dcterms:W3CDTF">2023-05-30T14:02:01Z</dcterms:modified>
</cp:coreProperties>
</file>